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797675" cy="9926638"/>
  <p:custDataLst>
    <p:tags r:id="rId4"/>
  </p:custDataLst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cs typeface="Arial" charset="0"/>
              </a:defRPr>
            </a:lvl1pPr>
          </a:lstStyle>
          <a:p>
            <a:pPr>
              <a:defRPr/>
            </a:pPr>
            <a:fld id="{B49C56FE-0D9C-C74B-A2DD-6CC496BDED3F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de-CH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de-CH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cs typeface="Arial" charset="0"/>
              </a:defRPr>
            </a:lvl1pPr>
          </a:lstStyle>
          <a:p>
            <a:pPr>
              <a:defRPr/>
            </a:pPr>
            <a:fld id="{616D9032-4B03-7849-B82F-EA6A7A8C379E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5725601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C1C8E-384F-FB4C-9A9E-E059F7E96B33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3153CD-BA0F-6B46-8135-123D674FB7A7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82490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F6D5AE-A47D-3044-B603-891790B57F59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67AB28-6438-C844-A641-8705107B422B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8598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3B5872-BB9F-F84C-AB4C-CAAD534B4841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3AEFD1-7CFA-5948-B71D-DEEE28BF25C0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0863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E4BC49-C48D-E44D-B212-B6CB2B09C659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1919C3-4306-C747-B22D-9E96978FFB52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92980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5E76AF-F1AA-D446-89E8-2ADDD53A6E6B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F941B9-992A-2D41-BA84-9E2D1A7DCE26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6178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9C9370-E80C-D441-8247-7CE50B4B2E73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A5EA46-6987-B94A-BA7E-98400704A7D6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78148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8F0F4C-1475-B240-AA26-B28A2A80C79A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75C44C-1BA0-9642-B9C9-41D1EA2B7C2D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67675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BDB38A-F1C9-F946-8992-58F11ACB9F18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F48D48-BCB5-4C48-B7F4-9305BB294C7C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70293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2D19FF-5C62-7444-BAB7-9B156A852F07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AB3927-CEAE-D540-9357-88951B19E49A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74537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56233D-16E9-2D44-AED2-9B89C14005BD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E911A0-E191-EC49-A2B6-F39B69B249D1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69912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CH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695A34-992B-2B48-8C5F-490C5925C01C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174AFE-87BC-5F49-BE78-BAD43C64D4C8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46174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cs typeface="Arial" charset="0"/>
              </a:defRPr>
            </a:lvl1pPr>
          </a:lstStyle>
          <a:p>
            <a:pPr>
              <a:defRPr/>
            </a:pPr>
            <a:fld id="{3AA7F55C-B592-994E-85C7-D4A135FE45C5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cs typeface="Arial" charset="0"/>
              </a:defRPr>
            </a:lvl1pPr>
          </a:lstStyle>
          <a:p>
            <a:pPr>
              <a:defRPr/>
            </a:pPr>
            <a:fld id="{2ED318BE-A981-B64C-8A29-B4B80A5084C4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>
            <a:spLocks noChangeArrowheads="1"/>
          </p:cNvSpPr>
          <p:nvPr/>
        </p:nvSpPr>
        <p:spPr bwMode="auto">
          <a:xfrm>
            <a:off x="2195736" y="548680"/>
            <a:ext cx="11572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200" dirty="0">
                <a:latin typeface="Arial"/>
                <a:cs typeface="Arial"/>
              </a:rPr>
              <a:t>Suppl. Table 1 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2005329"/>
              </p:ext>
            </p:extLst>
          </p:nvPr>
        </p:nvGraphicFramePr>
        <p:xfrm>
          <a:off x="2195736" y="980728"/>
          <a:ext cx="4896544" cy="37890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064"/>
                <a:gridCol w="1800200"/>
                <a:gridCol w="1728192"/>
                <a:gridCol w="792088"/>
              </a:tblGrid>
              <a:tr h="360040">
                <a:tc>
                  <a:txBody>
                    <a:bodyPr/>
                    <a:lstStyle/>
                    <a:p>
                      <a:pPr marL="0" indent="0"/>
                      <a:r>
                        <a:rPr lang="en-US" sz="1000" b="1">
                          <a:latin typeface="Arial"/>
                          <a:cs typeface="Arial"/>
                        </a:rPr>
                        <a:t>Gene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1"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indent="0">
                        <a:tabLst/>
                      </a:pPr>
                      <a:r>
                        <a:rPr lang="en-US" sz="1000" b="1"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1">
                          <a:latin typeface="Arial"/>
                          <a:cs typeface="Arial"/>
                        </a:rPr>
                        <a:t>Organism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Actinb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AACGGCTCCGGCATGTGC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CTCTTGCTCTGGGCCTCG</a:t>
                      </a: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/Mm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ntf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TCTGTAGCCGTTCTATCTG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GGTACACCATCCACTGAGTC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ox2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TGATGACTGCCCAACTCCC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AAGTGCTGGGCAAAGAATGC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Elavl1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ACCAGGCACAGAGATTCAG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GTAGATGAAGATGCACCAGC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/Mm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Fgf2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GCTGCTGGCTTCTAAGTGT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TCCGTGACCGGTAAGTGTTG</a:t>
                      </a: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apdh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ATGACTCTACCCACGGCAAG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GGAAGATGGTGATGGGTTTC</a:t>
                      </a: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Gapdh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CAGCAATGCATCCTGCACC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TGGACTGTGGTCATGAGCC</a:t>
                      </a: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Mm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fap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AGTGGTATCGGTCCAAGTTTGC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TGGCGGCGATAGTCATTAGC</a:t>
                      </a: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Hnrpd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AGCTGCCTATGGACAACAA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ATACTGCTCCTTCGACATGG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Ilf3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TGGAGAAACGCTATCAGTC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TCTAGCCTGGAACCACTTG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Khsrp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ATGCTGCTACCACCGTGAAT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TGTCTGGCTGGTCTCCATCT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Lif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ATGAAGGTCTTGGCCACAGG 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GTATGGCGCAGGTGGCATT</a:t>
                      </a: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Lif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AATGCCACCTGTGCCATACG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CAACTTGGTCTTCTCTGTCCC</a:t>
                      </a: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Mm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pl32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ＭＳ Ｐゴシック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ts val="13"/>
                        </a:spcBef>
                        <a:spcAft>
                          <a:spcPts val="13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AAGCGAAACTGGCGGAAAC</a:t>
                      </a:r>
                      <a:endParaRPr kumimoji="0" lang="de-CH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TAACCGATGTTGGGCATCAG</a:t>
                      </a: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/Mm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Times" charset="0"/>
                          <a:cs typeface="Arial"/>
                        </a:rPr>
                        <a:t>Ttp</a:t>
                      </a:r>
                      <a:endParaRPr kumimoji="0" lang="de-CH" sz="800" b="1" i="1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/>
                        <a:ea typeface="Times" charset="0"/>
                        <a:cs typeface="Arial"/>
                      </a:endParaRP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93663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TCGAAGAGACCCTAACCAGGC</a:t>
                      </a:r>
                    </a:p>
                  </a:txBody>
                  <a:tcPr marL="0" marR="0" marT="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GCGTAGTCATCAGGATCGGA</a:t>
                      </a:r>
                    </a:p>
                  </a:txBody>
                  <a:tcPr marL="32833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  Rn/Mm</a:t>
                      </a:r>
                    </a:p>
                  </a:txBody>
                  <a:tcPr marL="54722" marR="5983" marT="5990" marB="0" anchor="ctr" horzOverflow="overflow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092923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24a27946-27ce-4cce-937e-4fb1055063d8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8</Words>
  <Application>Microsoft Office PowerPoint</Application>
  <PresentationFormat>On-screen Show (4:3)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</vt:lpstr>
      <vt:lpstr>Office Theme</vt:lpstr>
      <vt:lpstr>PowerPoint Presentation</vt:lpstr>
    </vt:vector>
  </TitlesOfParts>
  <Company>Inselspita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gca, Cavit</dc:creator>
  <cp:lastModifiedBy>cavit agca</cp:lastModifiedBy>
  <cp:revision>79</cp:revision>
  <cp:lastPrinted>2014-06-19T09:40:11Z</cp:lastPrinted>
  <dcterms:created xsi:type="dcterms:W3CDTF">2014-04-10T08:05:20Z</dcterms:created>
  <dcterms:modified xsi:type="dcterms:W3CDTF">2015-01-07T09:35:01Z</dcterms:modified>
</cp:coreProperties>
</file>